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87" r:id="rId4"/>
    <p:sldId id="267" r:id="rId5"/>
    <p:sldId id="268" r:id="rId6"/>
    <p:sldId id="283" r:id="rId7"/>
    <p:sldId id="282" r:id="rId8"/>
    <p:sldId id="284" r:id="rId9"/>
    <p:sldId id="288" r:id="rId10"/>
    <p:sldId id="289" r:id="rId11"/>
    <p:sldId id="290" r:id="rId12"/>
    <p:sldId id="270" r:id="rId13"/>
    <p:sldId id="260" r:id="rId14"/>
    <p:sldId id="262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8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5697C1-60F2-4CC2-8739-898A6C6545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B164F6-D919-42E0-85CE-F3312E916A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247366-C2BF-4800-A139-A08180061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910E2-B8B0-42A3-A5D6-490E98DFB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DFA56-2591-4FCF-8F77-4C9DAB800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356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59F35-951C-4EDF-8872-3089DF1B20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31170F-28D7-442F-BF0D-32A28E7D3E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EFB2FE-03B8-442F-A393-498E7AEBB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CAEBF2-BD9D-453A-B581-6C4FAAD76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D1B147-BD4C-49D6-92C5-71D0048D9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014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61D17B-7468-4DD9-B110-BF6E8C9B06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DCD120-DF6C-403E-926F-1FDFFFFBF5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74CFD-C8BA-4F5F-B1D3-6193A1012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5A8425-3958-4B35-B03A-22B1F30F9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BC7A38-C9B8-451B-97F9-FB990BA63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326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CFAE8-E59E-4527-9883-CBDC4CA935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A53462-3847-4AAE-BE05-4D1583D9CE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2DD6EB-7B21-4B10-819F-2744F43D0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51D390-3AD2-4400-B1B2-E626DADC9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F2FF44-C127-4C9D-87BF-27A5A8D59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882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4F3D2-3994-41E4-B62A-540BA6498B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28DE63-0C32-4400-AEFA-4E5635B63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4FDBDB-E2C1-4DA2-91FF-31AB7202E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70971A-2D91-4498-BF93-2FDCDC764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964DFC-A3FE-4040-ADDC-BCA545598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51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B501A-7521-44BE-84A4-08A57401D0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C97B60-DBAF-40E6-A74F-28EFD7FCBA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4E0FBA-D163-486B-B714-DD34D3165E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7AC517-FD96-4292-B54A-5BA8E2CBF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049B46-2922-4615-93E8-8393B49BB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CAF70A-3B9A-44BD-916A-07D84D1B3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6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266F4-5AB6-49C3-A3DA-7325C0DE2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701292-9E43-4A7B-878B-08F900728A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A117AE-BDAB-4D55-A1C4-1DB6DD73D0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23DD1C-400F-4809-8BE7-2CD8E8F4CD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A3BA2E-75C3-4FB1-A22F-EF7BFA1E34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0C385B-3779-49C8-98AD-476110F6A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3810D9-BDE3-497A-A0C1-F08BB9915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DCBEC8-DCCE-402E-812E-866BDA72F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68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9E39A-0CD6-4726-8F56-7152DDCDCC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03D3C7-81FC-4039-BA3A-019F0A8B5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F6CA7-671A-479D-A012-52885019A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D906C7-06A1-4E4F-97FA-7EE18AC97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713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15FD78-5C84-4A74-BF65-27D9A1E32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AC11DE-0A7C-4347-AB43-C0D08A6F5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8554A5-D3A6-430B-AD93-B06B72CEE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92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90B339-B316-4B3E-92B9-C144972B8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72E8F-2F3A-49F6-9663-1BAB9D713A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657686-B60C-46FE-BDA3-7265A3E006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034C01-5245-48E6-835E-DEBC30EC9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8D88B0-0DA4-4536-999A-2E7FE02B5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268232-E923-4282-8481-F4AE34A9D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113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5CDDD-3447-4985-B9A4-D75BBDAEE0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AD13D5-ACA6-430D-B97D-46EEE20466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D5EE1A-AFFB-460B-BC6C-29AA60FB5E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C13894-ADDB-4DF1-9E99-4BB447409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F9C34C-DA0F-4781-9F99-51332644C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39EA03-043F-4560-9853-DC1C967AC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621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A3BAE2-09F5-4C76-BE50-09EE85BF3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A2B3C7-F7FE-41B9-84BF-A15E09FD5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C9C0FA-1803-4E04-8EC7-66279AC8F0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44D1F-2682-4C97-98FC-5657D5A9C782}" type="datetimeFigureOut">
              <a:rPr lang="en-US" smtClean="0"/>
              <a:t>7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24401B-B93E-486F-AB93-23273A5FC6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91420D-7F79-48D8-B5C6-5BBC06DB43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F80DA-558B-4809-AD1C-A07760E2C7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808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8.sv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8DBB0-7EB8-4B4F-8BB9-C5B4F813F58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 and tables </a:t>
            </a:r>
          </a:p>
        </p:txBody>
      </p:sp>
    </p:spTree>
    <p:extLst>
      <p:ext uri="{BB962C8B-B14F-4D97-AF65-F5344CB8AC3E}">
        <p14:creationId xmlns:p14="http://schemas.microsoft.com/office/powerpoint/2010/main" val="30604777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75BA91-2271-40C1-8E96-348A409D5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27400" y="1104105"/>
            <a:ext cx="5842000" cy="315911"/>
          </a:xfrm>
        </p:spPr>
        <p:txBody>
          <a:bodyPr>
            <a:normAutofit/>
          </a:bodyPr>
          <a:lstStyle/>
          <a:p>
            <a:pPr algn="ctr"/>
            <a:r>
              <a:rPr lang="en-US" sz="1200" dirty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Table S2: Statistics of clean data after QC and trimming  </a:t>
            </a:r>
            <a:endParaRPr lang="en-US" sz="1200" dirty="0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AE74577B-2573-4288-AEDE-4353EB2DB92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8977645"/>
              </p:ext>
            </p:extLst>
          </p:nvPr>
        </p:nvGraphicFramePr>
        <p:xfrm>
          <a:off x="2328863" y="1972472"/>
          <a:ext cx="8115297" cy="3781423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911191">
                  <a:extLst>
                    <a:ext uri="{9D8B030D-6E8A-4147-A177-3AD203B41FA5}">
                      <a16:colId xmlns:a16="http://schemas.microsoft.com/office/drawing/2014/main" val="2854509091"/>
                    </a:ext>
                  </a:extLst>
                </a:gridCol>
                <a:gridCol w="1116208">
                  <a:extLst>
                    <a:ext uri="{9D8B030D-6E8A-4147-A177-3AD203B41FA5}">
                      <a16:colId xmlns:a16="http://schemas.microsoft.com/office/drawing/2014/main" val="1619669653"/>
                    </a:ext>
                  </a:extLst>
                </a:gridCol>
                <a:gridCol w="1099125">
                  <a:extLst>
                    <a:ext uri="{9D8B030D-6E8A-4147-A177-3AD203B41FA5}">
                      <a16:colId xmlns:a16="http://schemas.microsoft.com/office/drawing/2014/main" val="3026196918"/>
                    </a:ext>
                  </a:extLst>
                </a:gridCol>
                <a:gridCol w="1099125">
                  <a:extLst>
                    <a:ext uri="{9D8B030D-6E8A-4147-A177-3AD203B41FA5}">
                      <a16:colId xmlns:a16="http://schemas.microsoft.com/office/drawing/2014/main" val="2785319556"/>
                    </a:ext>
                  </a:extLst>
                </a:gridCol>
                <a:gridCol w="939666">
                  <a:extLst>
                    <a:ext uri="{9D8B030D-6E8A-4147-A177-3AD203B41FA5}">
                      <a16:colId xmlns:a16="http://schemas.microsoft.com/office/drawing/2014/main" val="3172296206"/>
                    </a:ext>
                  </a:extLst>
                </a:gridCol>
                <a:gridCol w="1099125">
                  <a:extLst>
                    <a:ext uri="{9D8B030D-6E8A-4147-A177-3AD203B41FA5}">
                      <a16:colId xmlns:a16="http://schemas.microsoft.com/office/drawing/2014/main" val="2921996110"/>
                    </a:ext>
                  </a:extLst>
                </a:gridCol>
                <a:gridCol w="939666">
                  <a:extLst>
                    <a:ext uri="{9D8B030D-6E8A-4147-A177-3AD203B41FA5}">
                      <a16:colId xmlns:a16="http://schemas.microsoft.com/office/drawing/2014/main" val="1923162839"/>
                    </a:ext>
                  </a:extLst>
                </a:gridCol>
                <a:gridCol w="911191">
                  <a:extLst>
                    <a:ext uri="{9D8B030D-6E8A-4147-A177-3AD203B41FA5}">
                      <a16:colId xmlns:a16="http://schemas.microsoft.com/office/drawing/2014/main" val="3882886275"/>
                    </a:ext>
                  </a:extLst>
                </a:gridCol>
              </a:tblGrid>
              <a:tr h="227519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d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e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0(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0(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 (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6551322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91546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5E+0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E+0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1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24552362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99668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6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6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5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1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7033394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76606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4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1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7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58643938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86395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4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6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6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1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2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8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53913388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3846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2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4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7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5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4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8935581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80844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4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5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9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8847990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32708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2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7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8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5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7621030"/>
                  </a:ext>
                </a:extLst>
              </a:tr>
              <a:tr h="444238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27163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6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1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610041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018334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7A7A92-D538-46D1-94BD-3842E85D5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32971" y="823315"/>
            <a:ext cx="5842000" cy="425628"/>
          </a:xfrm>
        </p:spPr>
        <p:txBody>
          <a:bodyPr>
            <a:normAutofit/>
          </a:bodyPr>
          <a:lstStyle/>
          <a:p>
            <a:pPr algn="ctr"/>
            <a:r>
              <a:rPr lang="en-US" sz="1200" dirty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</a:rPr>
              <a:t>Table S3. Statistics of reads alignments </a:t>
            </a:r>
            <a:endParaRPr lang="en-US" sz="1200" dirty="0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AB4FE670-0446-4EA1-B4A5-46FE02B248E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87556506"/>
              </p:ext>
            </p:extLst>
          </p:nvPr>
        </p:nvGraphicFramePr>
        <p:xfrm>
          <a:off x="1285875" y="1866901"/>
          <a:ext cx="8467725" cy="411480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889639">
                  <a:extLst>
                    <a:ext uri="{9D8B030D-6E8A-4147-A177-3AD203B41FA5}">
                      <a16:colId xmlns:a16="http://schemas.microsoft.com/office/drawing/2014/main" val="1497340874"/>
                    </a:ext>
                  </a:extLst>
                </a:gridCol>
                <a:gridCol w="1456164">
                  <a:extLst>
                    <a:ext uri="{9D8B030D-6E8A-4147-A177-3AD203B41FA5}">
                      <a16:colId xmlns:a16="http://schemas.microsoft.com/office/drawing/2014/main" val="2970625574"/>
                    </a:ext>
                  </a:extLst>
                </a:gridCol>
                <a:gridCol w="1841745">
                  <a:extLst>
                    <a:ext uri="{9D8B030D-6E8A-4147-A177-3AD203B41FA5}">
                      <a16:colId xmlns:a16="http://schemas.microsoft.com/office/drawing/2014/main" val="1471314056"/>
                    </a:ext>
                  </a:extLst>
                </a:gridCol>
                <a:gridCol w="1510016">
                  <a:extLst>
                    <a:ext uri="{9D8B030D-6E8A-4147-A177-3AD203B41FA5}">
                      <a16:colId xmlns:a16="http://schemas.microsoft.com/office/drawing/2014/main" val="792515385"/>
                    </a:ext>
                  </a:extLst>
                </a:gridCol>
                <a:gridCol w="1800819">
                  <a:extLst>
                    <a:ext uri="{9D8B030D-6E8A-4147-A177-3AD203B41FA5}">
                      <a16:colId xmlns:a16="http://schemas.microsoft.com/office/drawing/2014/main" val="2060761266"/>
                    </a:ext>
                  </a:extLst>
                </a:gridCol>
                <a:gridCol w="969342">
                  <a:extLst>
                    <a:ext uri="{9D8B030D-6E8A-4147-A177-3AD203B41FA5}">
                      <a16:colId xmlns:a16="http://schemas.microsoft.com/office/drawing/2014/main" val="2530082665"/>
                    </a:ext>
                  </a:extLst>
                </a:gridCol>
              </a:tblGrid>
              <a:tr h="476456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ID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read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q mapped read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q mapped %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q same chr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8880356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91546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78368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1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90897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1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7174191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99668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09907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4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96936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8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18904869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76606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5640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5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48834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1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40505167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86395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41350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6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48077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18858917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3846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72047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47695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5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9533984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80844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58800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9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50100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4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00785875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32708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87258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5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11689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8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3917853"/>
                  </a:ext>
                </a:extLst>
              </a:tr>
              <a:tr h="454793"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27163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70815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3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28982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6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055219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521162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F85AA07-0DAD-48EE-B75F-571D8FE193F3}"/>
              </a:ext>
            </a:extLst>
          </p:cNvPr>
          <p:cNvSpPr/>
          <p:nvPr/>
        </p:nvSpPr>
        <p:spPr>
          <a:xfrm>
            <a:off x="2595564" y="1276351"/>
            <a:ext cx="732601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4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mmary of gene ontology and KEGG enrichment of DMR between wil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cultivate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yvali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fruits and leaves in different fruit maturation phases (A: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yvali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D: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J: July; N: November; L: leaf; F: fruit).</a:t>
            </a:r>
            <a:endParaRPr lang="en-US" sz="1200" i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A6E9BF0-2339-440B-AE8C-F8D8100B2A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8971152"/>
              </p:ext>
            </p:extLst>
          </p:nvPr>
        </p:nvGraphicFramePr>
        <p:xfrm>
          <a:off x="2033588" y="2176463"/>
          <a:ext cx="8524877" cy="2262187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1175038">
                  <a:extLst>
                    <a:ext uri="{9D8B030D-6E8A-4147-A177-3AD203B41FA5}">
                      <a16:colId xmlns:a16="http://schemas.microsoft.com/office/drawing/2014/main" val="824290472"/>
                    </a:ext>
                  </a:extLst>
                </a:gridCol>
                <a:gridCol w="511212">
                  <a:extLst>
                    <a:ext uri="{9D8B030D-6E8A-4147-A177-3AD203B41FA5}">
                      <a16:colId xmlns:a16="http://schemas.microsoft.com/office/drawing/2014/main" val="4109395804"/>
                    </a:ext>
                  </a:extLst>
                </a:gridCol>
                <a:gridCol w="511212">
                  <a:extLst>
                    <a:ext uri="{9D8B030D-6E8A-4147-A177-3AD203B41FA5}">
                      <a16:colId xmlns:a16="http://schemas.microsoft.com/office/drawing/2014/main" val="3495510240"/>
                    </a:ext>
                  </a:extLst>
                </a:gridCol>
                <a:gridCol w="511212">
                  <a:extLst>
                    <a:ext uri="{9D8B030D-6E8A-4147-A177-3AD203B41FA5}">
                      <a16:colId xmlns:a16="http://schemas.microsoft.com/office/drawing/2014/main" val="3015150807"/>
                    </a:ext>
                  </a:extLst>
                </a:gridCol>
                <a:gridCol w="2522352">
                  <a:extLst>
                    <a:ext uri="{9D8B030D-6E8A-4147-A177-3AD203B41FA5}">
                      <a16:colId xmlns:a16="http://schemas.microsoft.com/office/drawing/2014/main" val="2910209528"/>
                    </a:ext>
                  </a:extLst>
                </a:gridCol>
                <a:gridCol w="1524272">
                  <a:extLst>
                    <a:ext uri="{9D8B030D-6E8A-4147-A177-3AD203B41FA5}">
                      <a16:colId xmlns:a16="http://schemas.microsoft.com/office/drawing/2014/main" val="673356359"/>
                    </a:ext>
                  </a:extLst>
                </a:gridCol>
                <a:gridCol w="1769579">
                  <a:extLst>
                    <a:ext uri="{9D8B030D-6E8A-4147-A177-3AD203B41FA5}">
                      <a16:colId xmlns:a16="http://schemas.microsoft.com/office/drawing/2014/main" val="1282239547"/>
                    </a:ext>
                  </a:extLst>
                </a:gridCol>
              </a:tblGrid>
              <a:tr h="465117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200" baseline="30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GO term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200" baseline="30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KEGG enriched pathway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 coun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GG cou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1906326"/>
                  </a:ext>
                </a:extLst>
              </a:tr>
              <a:tr h="46511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6642573"/>
                  </a:ext>
                </a:extLst>
              </a:tr>
              <a:tr h="25468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F-D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8159040"/>
                  </a:ext>
                </a:extLst>
              </a:tr>
              <a:tr h="2155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F-D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1611936"/>
                  </a:ext>
                </a:extLst>
              </a:tr>
              <a:tr h="32874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L-DJ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5572191"/>
                  </a:ext>
                </a:extLst>
              </a:tr>
              <a:tr h="53294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L-DN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08244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9894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14663" y="1123633"/>
            <a:ext cx="69437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cis-elements at the lipoxygenase 1 (Oeu003662.1)  involved in the methylated peak/site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0203779"/>
              </p:ext>
            </p:extLst>
          </p:nvPr>
        </p:nvGraphicFramePr>
        <p:xfrm>
          <a:off x="1271589" y="1885950"/>
          <a:ext cx="10467974" cy="4577460"/>
        </p:xfrm>
        <a:graphic>
          <a:graphicData uri="http://schemas.openxmlformats.org/drawingml/2006/table">
            <a:tbl>
              <a:tblPr/>
              <a:tblGrid>
                <a:gridCol w="1384810">
                  <a:extLst>
                    <a:ext uri="{9D8B030D-6E8A-4147-A177-3AD203B41FA5}">
                      <a16:colId xmlns:a16="http://schemas.microsoft.com/office/drawing/2014/main" val="468973868"/>
                    </a:ext>
                  </a:extLst>
                </a:gridCol>
                <a:gridCol w="1399700">
                  <a:extLst>
                    <a:ext uri="{9D8B030D-6E8A-4147-A177-3AD203B41FA5}">
                      <a16:colId xmlns:a16="http://schemas.microsoft.com/office/drawing/2014/main" val="87729473"/>
                    </a:ext>
                  </a:extLst>
                </a:gridCol>
                <a:gridCol w="4303336">
                  <a:extLst>
                    <a:ext uri="{9D8B030D-6E8A-4147-A177-3AD203B41FA5}">
                      <a16:colId xmlns:a16="http://schemas.microsoft.com/office/drawing/2014/main" val="416697958"/>
                    </a:ext>
                  </a:extLst>
                </a:gridCol>
                <a:gridCol w="1593277">
                  <a:extLst>
                    <a:ext uri="{9D8B030D-6E8A-4147-A177-3AD203B41FA5}">
                      <a16:colId xmlns:a16="http://schemas.microsoft.com/office/drawing/2014/main" val="1767361425"/>
                    </a:ext>
                  </a:extLst>
                </a:gridCol>
                <a:gridCol w="1786851">
                  <a:extLst>
                    <a:ext uri="{9D8B030D-6E8A-4147-A177-3AD203B41FA5}">
                      <a16:colId xmlns:a16="http://schemas.microsoft.com/office/drawing/2014/main" val="3675581169"/>
                    </a:ext>
                  </a:extLst>
                </a:gridCol>
              </a:tblGrid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ld Oleaster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yvalik cv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ailed Matrix Information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st cis-element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 cis-element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5763765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BI4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BI4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A insensitive protein 4 (ABI4)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2385288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S1_AS2_II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S1_AS2_II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1/AS2 repressor complex binding motif II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1586832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THB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THB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Zi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lass I protein ATHB5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5815630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CAAT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CAAT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T-box in plant promoter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6687678"/>
                  </a:ext>
                </a:extLst>
              </a:tr>
              <a:tr h="440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GMNAC30_81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GMNAC30_81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dimer of NAC-domain transcription factor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2524500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MYB46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MYB46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b domain protein 46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7969303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MYB58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MYB58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omain protein 58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7441880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MYB67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MYB67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b domain protein 67 (ATY53)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727097"/>
                  </a:ext>
                </a:extLst>
              </a:tr>
              <a:tr h="440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RAV1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RAV1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2/ERF and B3 domain-containing transcription factor RAV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5400579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BP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BP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 promoter binding protein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7493978"/>
                  </a:ext>
                </a:extLst>
              </a:tr>
              <a:tr h="3696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PL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PL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mosa promoter-binding-like protein 14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37814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45968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4352339"/>
              </p:ext>
            </p:extLst>
          </p:nvPr>
        </p:nvGraphicFramePr>
        <p:xfrm>
          <a:off x="1370077" y="1500188"/>
          <a:ext cx="9405938" cy="4779012"/>
        </p:xfrm>
        <a:graphic>
          <a:graphicData uri="http://schemas.openxmlformats.org/drawingml/2006/table">
            <a:tbl>
              <a:tblPr/>
              <a:tblGrid>
                <a:gridCol w="1265514">
                  <a:extLst>
                    <a:ext uri="{9D8B030D-6E8A-4147-A177-3AD203B41FA5}">
                      <a16:colId xmlns:a16="http://schemas.microsoft.com/office/drawing/2014/main" val="776419089"/>
                    </a:ext>
                  </a:extLst>
                </a:gridCol>
                <a:gridCol w="1319300">
                  <a:extLst>
                    <a:ext uri="{9D8B030D-6E8A-4147-A177-3AD203B41FA5}">
                      <a16:colId xmlns:a16="http://schemas.microsoft.com/office/drawing/2014/main" val="808768365"/>
                    </a:ext>
                  </a:extLst>
                </a:gridCol>
                <a:gridCol w="3594061">
                  <a:extLst>
                    <a:ext uri="{9D8B030D-6E8A-4147-A177-3AD203B41FA5}">
                      <a16:colId xmlns:a16="http://schemas.microsoft.com/office/drawing/2014/main" val="1150647753"/>
                    </a:ext>
                  </a:extLst>
                </a:gridCol>
                <a:gridCol w="1581893">
                  <a:extLst>
                    <a:ext uri="{9D8B030D-6E8A-4147-A177-3AD203B41FA5}">
                      <a16:colId xmlns:a16="http://schemas.microsoft.com/office/drawing/2014/main" val="1191872049"/>
                    </a:ext>
                  </a:extLst>
                </a:gridCol>
                <a:gridCol w="1645170">
                  <a:extLst>
                    <a:ext uri="{9D8B030D-6E8A-4147-A177-3AD203B41FA5}">
                      <a16:colId xmlns:a16="http://schemas.microsoft.com/office/drawing/2014/main" val="3508642477"/>
                    </a:ext>
                  </a:extLst>
                </a:gridCol>
              </a:tblGrid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ld Oleaster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yvalik cv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ailed Matrix Information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st cis-element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 cis-element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6257379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$LTATA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tivirus LTR TATA box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st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5894235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$PTATA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t TATA box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7141895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$VTATA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r and viral TATA box element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4689156"/>
                  </a:ext>
                </a:extLst>
              </a:tr>
              <a:tr h="3705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GL1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GL1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L15, Arabidopsis MADS-domain protein AGAMOUS-like 15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0148912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S1_AS2_II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S1_AS2_II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1/AS2 repressor complex binding motif II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6404032"/>
                  </a:ext>
                </a:extLst>
              </a:tr>
              <a:tr h="3705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NTL6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C WITH TRANSMEMBRANE MOTIF 1-LIKE 6 (NTL6/NTM1)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st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0187264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T1G20910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ID/BRIGHT DNA-binding domain-containing protein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9443192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T1G74840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b family transcription factor AT1G74840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4821422"/>
                  </a:ext>
                </a:extLst>
              </a:tr>
              <a:tr h="37879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ATSTKL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-binding storekeeper protein-related transcriptional regulator (AT4G00250)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1143358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CCA1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rcadian clock associated 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0595753"/>
                  </a:ext>
                </a:extLst>
              </a:tr>
              <a:tr h="37879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PBOX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lamin box, conserved in cereal seed storage protein gene promoter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0316877"/>
                  </a:ext>
                </a:extLst>
              </a:tr>
              <a:tr h="37879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RAV1-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RAV1-5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-part of bipartite RAV1 binding site, interacting with AP2 domain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8102738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NBE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ondary wall NAC binding element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1438124"/>
                  </a:ext>
                </a:extLst>
              </a:tr>
              <a:tr h="37879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UCROSE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SUCROSE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motif from the promoters of different sugar-responsive genes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701513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TCX2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TCX2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MIN/TSO1-like CXC 2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5368376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TOE2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 of early activation tagged (EAT) 2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st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6813724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WRKY50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WRKY50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RKY DNA-binding protein 50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2596646"/>
                  </a:ext>
                </a:extLst>
              </a:tr>
              <a:tr h="1939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$ZMMRP1.01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ea mays MYB-related protein 1 (transfer cell specific)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ined</a:t>
                      </a:r>
                    </a:p>
                  </a:txBody>
                  <a:tcPr marL="5292" marR="5292" marT="529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6551620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657476" y="624129"/>
            <a:ext cx="71745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cis-elements at the methylation site for the fatty acid desaturase-3 (Oeu032520) promoter</a:t>
            </a:r>
          </a:p>
        </p:txBody>
      </p:sp>
    </p:spTree>
    <p:extLst>
      <p:ext uri="{BB962C8B-B14F-4D97-AF65-F5344CB8AC3E}">
        <p14:creationId xmlns:p14="http://schemas.microsoft.com/office/powerpoint/2010/main" val="12012872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872F3F5-9C07-40AD-8C90-3C41F4FBCA3B}"/>
              </a:ext>
            </a:extLst>
          </p:cNvPr>
          <p:cNvSpPr/>
          <p:nvPr/>
        </p:nvSpPr>
        <p:spPr>
          <a:xfrm>
            <a:off x="1300163" y="5572443"/>
            <a:ext cx="911066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556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Differential methylation between leaves and fruit in wild and cultivated olive trees. 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in Ayvalik between immature fruits and leaves in July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in Ayvalik between ripened fruits and leaves in November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in wil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easter 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etween immature fruits and leaves in July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in wil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easter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tween ripened fruits and leaves in November. DMR: differentially methylated region, ANF: Ayvalik November fruit, DNF: wild November fruit. AJF: Ayvalik July fruit, DJF: wild July fruit, where Delice is the Turkish name of the wild oleaster, TSS: transcription starting site, TTS: transcription termination site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28C0FB39-A7F0-4154-9992-CF55EF823752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8406" y="714375"/>
            <a:ext cx="7215187" cy="4639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6773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B9E2B-4312-4A37-A3A2-9A56DA7E5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09687" y="5929314"/>
            <a:ext cx="9572625" cy="691072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</a:pP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.  Differential methylated profile between the wild oleaster (Delice) and cultivated Ayvalik within the 23 olive chromosomes.</a:t>
            </a:r>
            <a:b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p figure : global hypomethylation with fruit maturity between July and November for Ayvalik fruits</a:t>
            </a:r>
            <a:b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ttom figure : global hypomethylation with fruit maturity between July and November for wild oleaster fruits</a:t>
            </a:r>
            <a:b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JF: Ayvalik July fruits; ANF: Ayvalik November fruit; DJF wild July fruits DNF wild November frui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DA8DAF47-A100-4C8F-90A0-1704E358E2B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863192" y="1179197"/>
            <a:ext cx="9000600" cy="234505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E3C3927-32A9-45CE-9774-3D30922CE6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1394" y="3698521"/>
            <a:ext cx="8816673" cy="2095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64036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3F15F0B-BA05-4AA4-B6C9-2E362F0DC3E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943102" y="867110"/>
            <a:ext cx="8011054" cy="469406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F398EE6-E316-4B16-B45F-811FF3A267BB}"/>
              </a:ext>
            </a:extLst>
          </p:cNvPr>
          <p:cNvSpPr/>
          <p:nvPr/>
        </p:nvSpPr>
        <p:spPr>
          <a:xfrm>
            <a:off x="581025" y="5843033"/>
            <a:ext cx="1104423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556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. Differential methylated region in fruits and leaves between July and November in wild and cultivated olive trees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immature and ripened fruits for cultivated Ayvalik,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immature and ripened fruits for wild Oleaster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MR between leaves in July and November for cultivated Ayvalik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leaves in July and November for wild oleaster. ANF: Ayvalik November fruit, DNF: wild November fruit. AJF: Ayvalik July fruit, DJF: wild July fruit, where Delice is the Turkish name of the wild oleaster, TSS: transcription starting site, TTS: transcription termination site.</a:t>
            </a:r>
            <a:endParaRPr lang="en-US" sz="1200" i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9C38B0-A590-41A3-8F1A-2D3F21681353}"/>
              </a:ext>
            </a:extLst>
          </p:cNvPr>
          <p:cNvSpPr txBox="1"/>
          <p:nvPr/>
        </p:nvSpPr>
        <p:spPr>
          <a:xfrm>
            <a:off x="2809975" y="620889"/>
            <a:ext cx="280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360170-9D3F-417E-B759-E67622B5D859}"/>
              </a:ext>
            </a:extLst>
          </p:cNvPr>
          <p:cNvSpPr txBox="1"/>
          <p:nvPr/>
        </p:nvSpPr>
        <p:spPr>
          <a:xfrm>
            <a:off x="2832343" y="2052239"/>
            <a:ext cx="280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87D21D-558E-49F9-BDCD-7F652030D4B5}"/>
              </a:ext>
            </a:extLst>
          </p:cNvPr>
          <p:cNvSpPr txBox="1"/>
          <p:nvPr/>
        </p:nvSpPr>
        <p:spPr>
          <a:xfrm>
            <a:off x="9041450" y="2095818"/>
            <a:ext cx="280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5B5D93-D9C7-409A-AEEF-FBFDB502F885}"/>
              </a:ext>
            </a:extLst>
          </p:cNvPr>
          <p:cNvSpPr txBox="1"/>
          <p:nvPr/>
        </p:nvSpPr>
        <p:spPr>
          <a:xfrm>
            <a:off x="9041450" y="568170"/>
            <a:ext cx="280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713746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30AF26C-EBC6-4EB8-A81B-4383F031B893}"/>
              </a:ext>
            </a:extLst>
          </p:cNvPr>
          <p:cNvSpPr/>
          <p:nvPr/>
        </p:nvSpPr>
        <p:spPr>
          <a:xfrm>
            <a:off x="357188" y="6113522"/>
            <a:ext cx="1161573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556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Differential methylated region in fruits and leaves between wild and cultivated olive trees in different maturation stages. 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yvali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 in July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yvali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 in November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ultivated olive trees in different maturation stage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yvali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 in July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MR betwee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yvali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uits in November. DMR: differentially methylated region, ANF: Ayvalik November fruit, DNF: wild November fruit. AJF: Ayvalik July fruit, DJF: wild July fruit, where Delice is the Turkish name of the wild oleaster, TSS: transcription starting site, TTS: transcription termination site.</a:t>
            </a:r>
            <a:endParaRPr lang="en-US" sz="1200" i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CF60768-307D-43FC-95DD-473F480ADE89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58"/>
          <a:stretch/>
        </p:blipFill>
        <p:spPr>
          <a:xfrm>
            <a:off x="1637770" y="960120"/>
            <a:ext cx="7772400" cy="4937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0090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5260FFC-3D5B-40D1-833F-03573382452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9334" y="815703"/>
            <a:ext cx="2904802" cy="4562417"/>
          </a:xfrm>
        </p:spPr>
      </p:pic>
      <p:pic>
        <p:nvPicPr>
          <p:cNvPr id="7" name="Graphic 6" descr="Binoculars">
            <a:extLst>
              <a:ext uri="{FF2B5EF4-FFF2-40B4-BE49-F238E27FC236}">
                <a16:creationId xmlns:a16="http://schemas.microsoft.com/office/drawing/2014/main" id="{2B02F417-8682-4751-AE82-960A5FC011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 rot="16200000">
            <a:off x="5399674" y="3279490"/>
            <a:ext cx="428924" cy="428924"/>
          </a:xfrm>
          <a:prstGeom prst="rect">
            <a:avLst/>
          </a:prstGeom>
        </p:spPr>
      </p:pic>
      <p:pic>
        <p:nvPicPr>
          <p:cNvPr id="9" name="Picture 8" descr="Background pattern&#10;&#10;Description automatically generated">
            <a:extLst>
              <a:ext uri="{FF2B5EF4-FFF2-40B4-BE49-F238E27FC236}">
                <a16:creationId xmlns:a16="http://schemas.microsoft.com/office/drawing/2014/main" id="{64DE5FAC-A852-476F-82DC-AF78E372D6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8752" y="43130"/>
            <a:ext cx="3683914" cy="593005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73C7D0C-0DA6-4E4A-BD85-A99EC1B44C33}"/>
              </a:ext>
            </a:extLst>
          </p:cNvPr>
          <p:cNvSpPr txBox="1"/>
          <p:nvPr/>
        </p:nvSpPr>
        <p:spPr>
          <a:xfrm>
            <a:off x="10088245" y="6568649"/>
            <a:ext cx="1942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JL : July leaf ;  NL November leaf </a:t>
            </a:r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67E31614-2FAE-448A-97CC-CDE0913B97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1913" y="6019840"/>
            <a:ext cx="10482261" cy="508002"/>
          </a:xfrm>
        </p:spPr>
        <p:txBody>
          <a:bodyPr>
            <a:norm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Heatmap of leaves DNA methyltransferases differential genes expression (DGE) between July and November ( DGE data published in Turgay et all 2017)</a:t>
            </a:r>
          </a:p>
        </p:txBody>
      </p:sp>
    </p:spTree>
    <p:extLst>
      <p:ext uri="{BB962C8B-B14F-4D97-AF65-F5344CB8AC3E}">
        <p14:creationId xmlns:p14="http://schemas.microsoft.com/office/powerpoint/2010/main" val="25906074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E144A-403F-42C4-A336-80413F90FF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1913" y="6058044"/>
            <a:ext cx="9810749" cy="411251"/>
          </a:xfrm>
        </p:spPr>
        <p:txBody>
          <a:bodyPr>
            <a:noAutofit/>
          </a:bodyPr>
          <a:lstStyle/>
          <a:p>
            <a:pPr algn="ctr" defTabSz="254020">
              <a:lnSpc>
                <a:spcPct val="107000"/>
              </a:lnSpc>
              <a:spcBef>
                <a:spcPts val="0"/>
              </a:spcBef>
              <a:defRPr/>
            </a:pPr>
            <a:b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of fruit DNA methyltransferases differential genes expression between July and November ( DGE data published in Turgay et all 2017)  </a:t>
            </a:r>
            <a:b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C303D6C7-C20E-424A-ADC9-8AAE277855B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2466" y="1131402"/>
            <a:ext cx="3252822" cy="4346372"/>
          </a:xfrm>
        </p:spPr>
      </p:pic>
      <p:pic>
        <p:nvPicPr>
          <p:cNvPr id="7" name="Graphic 6" descr="Binoculars">
            <a:extLst>
              <a:ext uri="{FF2B5EF4-FFF2-40B4-BE49-F238E27FC236}">
                <a16:creationId xmlns:a16="http://schemas.microsoft.com/office/drawing/2014/main" id="{CC3FFCB9-CB2B-455A-86C9-9DA989EEC9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 rot="16200000">
            <a:off x="5334000" y="3175000"/>
            <a:ext cx="428924" cy="4289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A7F0460-7F9F-4809-B4A2-C777F2E057C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2925" y="551132"/>
            <a:ext cx="3537411" cy="520120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C89677D-0AB6-4533-8D9A-F57281966D8C}"/>
              </a:ext>
            </a:extLst>
          </p:cNvPr>
          <p:cNvSpPr txBox="1"/>
          <p:nvPr/>
        </p:nvSpPr>
        <p:spPr>
          <a:xfrm>
            <a:off x="9945789" y="6450101"/>
            <a:ext cx="2122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JF: July fruit,  NF November fruit </a:t>
            </a:r>
          </a:p>
        </p:txBody>
      </p:sp>
    </p:spTree>
    <p:extLst>
      <p:ext uri="{BB962C8B-B14F-4D97-AF65-F5344CB8AC3E}">
        <p14:creationId xmlns:p14="http://schemas.microsoft.com/office/powerpoint/2010/main" val="7937059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8960CB-6D16-4180-80F9-757E54F90B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94291" y="6191250"/>
            <a:ext cx="6878210" cy="442912"/>
          </a:xfrm>
        </p:spPr>
        <p:txBody>
          <a:bodyPr>
            <a:normAutofit fontScale="90000"/>
          </a:bodyPr>
          <a:lstStyle/>
          <a:p>
            <a:pPr algn="ctr" defTabSz="254020">
              <a:lnSpc>
                <a:spcPct val="107000"/>
              </a:lnSpc>
              <a:spcBef>
                <a:spcPts val="0"/>
              </a:spcBef>
              <a:defRPr/>
            </a:pPr>
            <a:br>
              <a:rPr lang="en-US" sz="1000" b="1" dirty="0">
                <a:solidFill>
                  <a:prstClr val="black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000" b="1" dirty="0">
                <a:solidFill>
                  <a:prstClr val="black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300" b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.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of fruits DNA demethylases differential genes expression between July and November</a:t>
            </a:r>
            <a:r>
              <a:rPr lang="en-US" sz="13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br>
              <a:rPr lang="en-US" sz="1000" dirty="0">
                <a:solidFill>
                  <a:prstClr val="black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  <p:pic>
        <p:nvPicPr>
          <p:cNvPr id="5" name="Content Placeholder 4" descr="A picture containing table&#10;&#10;Description automatically generated">
            <a:extLst>
              <a:ext uri="{FF2B5EF4-FFF2-40B4-BE49-F238E27FC236}">
                <a16:creationId xmlns:a16="http://schemas.microsoft.com/office/drawing/2014/main" id="{77E68587-B7E9-4706-ACD8-B313C12E1BB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586" y="99649"/>
            <a:ext cx="4665765" cy="6028090"/>
          </a:xfrm>
        </p:spPr>
      </p:pic>
    </p:spTree>
    <p:extLst>
      <p:ext uri="{BB962C8B-B14F-4D97-AF65-F5344CB8AC3E}">
        <p14:creationId xmlns:p14="http://schemas.microsoft.com/office/powerpoint/2010/main" val="40755534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60CF52-EA05-45CD-9079-F5D7619D68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12541" y="987929"/>
            <a:ext cx="5842000" cy="583779"/>
          </a:xfrm>
        </p:spPr>
        <p:txBody>
          <a:bodyPr>
            <a:normAutofit/>
          </a:bodyPr>
          <a:lstStyle/>
          <a:p>
            <a:pPr algn="ctr"/>
            <a:r>
              <a:rPr lang="en-US" sz="1200" dirty="0">
                <a:solidFill>
                  <a:srgbClr val="00000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solidFill>
                  <a:srgbClr val="00000A"/>
                </a:solidFill>
                <a:latin typeface="Times New Roman" panose="02020603050405020304" pitchFamily="18" charset="0"/>
                <a:ea typeface="Droid Sans Fallback"/>
                <a:cs typeface="Times New Roman" panose="02020603050405020304" pitchFamily="18" charset="0"/>
              </a:rPr>
              <a:t>Raw data statistic information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BF14F92-35BE-41D2-90D8-EE01E886D69D}"/>
              </a:ext>
            </a:extLst>
          </p:cNvPr>
          <p:cNvGraphicFramePr>
            <a:graphicFrameLocks noGrp="1"/>
          </p:cNvGraphicFramePr>
          <p:nvPr/>
        </p:nvGraphicFramePr>
        <p:xfrm>
          <a:off x="4587875" y="3086982"/>
          <a:ext cx="3016252" cy="19202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38667">
                  <a:extLst>
                    <a:ext uri="{9D8B030D-6E8A-4147-A177-3AD203B41FA5}">
                      <a16:colId xmlns:a16="http://schemas.microsoft.com/office/drawing/2014/main" val="1422939330"/>
                    </a:ext>
                  </a:extLst>
                </a:gridCol>
                <a:gridCol w="414867">
                  <a:extLst>
                    <a:ext uri="{9D8B030D-6E8A-4147-A177-3AD203B41FA5}">
                      <a16:colId xmlns:a16="http://schemas.microsoft.com/office/drawing/2014/main" val="2973574724"/>
                    </a:ext>
                  </a:extLst>
                </a:gridCol>
                <a:gridCol w="408517">
                  <a:extLst>
                    <a:ext uri="{9D8B030D-6E8A-4147-A177-3AD203B41FA5}">
                      <a16:colId xmlns:a16="http://schemas.microsoft.com/office/drawing/2014/main" val="1405376421"/>
                    </a:ext>
                  </a:extLst>
                </a:gridCol>
                <a:gridCol w="408517">
                  <a:extLst>
                    <a:ext uri="{9D8B030D-6E8A-4147-A177-3AD203B41FA5}">
                      <a16:colId xmlns:a16="http://schemas.microsoft.com/office/drawing/2014/main" val="2639134208"/>
                    </a:ext>
                  </a:extLst>
                </a:gridCol>
                <a:gridCol w="349250">
                  <a:extLst>
                    <a:ext uri="{9D8B030D-6E8A-4147-A177-3AD203B41FA5}">
                      <a16:colId xmlns:a16="http://schemas.microsoft.com/office/drawing/2014/main" val="2080171828"/>
                    </a:ext>
                  </a:extLst>
                </a:gridCol>
                <a:gridCol w="408517">
                  <a:extLst>
                    <a:ext uri="{9D8B030D-6E8A-4147-A177-3AD203B41FA5}">
                      <a16:colId xmlns:a16="http://schemas.microsoft.com/office/drawing/2014/main" val="1194354392"/>
                    </a:ext>
                  </a:extLst>
                </a:gridCol>
                <a:gridCol w="349250">
                  <a:extLst>
                    <a:ext uri="{9D8B030D-6E8A-4147-A177-3AD203B41FA5}">
                      <a16:colId xmlns:a16="http://schemas.microsoft.com/office/drawing/2014/main" val="2779817904"/>
                    </a:ext>
                  </a:extLst>
                </a:gridCol>
                <a:gridCol w="338667">
                  <a:extLst>
                    <a:ext uri="{9D8B030D-6E8A-4147-A177-3AD203B41FA5}">
                      <a16:colId xmlns:a16="http://schemas.microsoft.com/office/drawing/2014/main" val="2570538405"/>
                    </a:ext>
                  </a:extLst>
                </a:gridCol>
              </a:tblGrid>
              <a:tr h="104069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ample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Reads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ases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Q20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Q20(%)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Q30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Q30(%)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GC (%)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309645124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JF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33008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5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2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8.73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3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6.87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9.15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304624525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JL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947382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56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1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7.67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21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4.6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0.06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242910183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NF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105384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8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8.8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28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7.01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6.75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24362210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NL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7556936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62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8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7.88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29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5.02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8.84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172856562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JF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123112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8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35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8.05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18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5.35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7.44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38268163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JL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818541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55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39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7.64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19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4.55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9.55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77304773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NF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165627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8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35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7.94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17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5.18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8.07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117424264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NL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581529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45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31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7.88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.12E+09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4.93</a:t>
                      </a:r>
                      <a:endParaRPr lang="en-US" sz="70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38.66</a:t>
                      </a:r>
                      <a:endParaRPr lang="en-US" sz="700" dirty="0">
                        <a:solidFill>
                          <a:srgbClr val="00000A"/>
                        </a:solidFill>
                        <a:effectLst/>
                        <a:latin typeface="Liberation Serif"/>
                        <a:ea typeface="Droid Sans Fallback"/>
                        <a:cs typeface="FreeSans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val="958387472"/>
                  </a:ext>
                </a:extLst>
              </a:tr>
            </a:tbl>
          </a:graphicData>
        </a:graphic>
      </p:graphicFrame>
      <p:graphicFrame>
        <p:nvGraphicFramePr>
          <p:cNvPr id="11" name="Content Placeholder 10">
            <a:extLst>
              <a:ext uri="{FF2B5EF4-FFF2-40B4-BE49-F238E27FC236}">
                <a16:creationId xmlns:a16="http://schemas.microsoft.com/office/drawing/2014/main" id="{0C20339D-6EFA-471D-AD06-3AFB0A371F1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34766741"/>
              </p:ext>
            </p:extLst>
          </p:nvPr>
        </p:nvGraphicFramePr>
        <p:xfrm>
          <a:off x="3152777" y="1847850"/>
          <a:ext cx="6072186" cy="4162433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95311">
                  <a:extLst>
                    <a:ext uri="{9D8B030D-6E8A-4147-A177-3AD203B41FA5}">
                      <a16:colId xmlns:a16="http://schemas.microsoft.com/office/drawing/2014/main" val="2272968281"/>
                    </a:ext>
                  </a:extLst>
                </a:gridCol>
                <a:gridCol w="766763">
                  <a:extLst>
                    <a:ext uri="{9D8B030D-6E8A-4147-A177-3AD203B41FA5}">
                      <a16:colId xmlns:a16="http://schemas.microsoft.com/office/drawing/2014/main" val="2896477651"/>
                    </a:ext>
                  </a:extLst>
                </a:gridCol>
                <a:gridCol w="852487">
                  <a:extLst>
                    <a:ext uri="{9D8B030D-6E8A-4147-A177-3AD203B41FA5}">
                      <a16:colId xmlns:a16="http://schemas.microsoft.com/office/drawing/2014/main" val="1388238016"/>
                    </a:ext>
                  </a:extLst>
                </a:gridCol>
                <a:gridCol w="757238">
                  <a:extLst>
                    <a:ext uri="{9D8B030D-6E8A-4147-A177-3AD203B41FA5}">
                      <a16:colId xmlns:a16="http://schemas.microsoft.com/office/drawing/2014/main" val="3898347860"/>
                    </a:ext>
                  </a:extLst>
                </a:gridCol>
                <a:gridCol w="785812">
                  <a:extLst>
                    <a:ext uri="{9D8B030D-6E8A-4147-A177-3AD203B41FA5}">
                      <a16:colId xmlns:a16="http://schemas.microsoft.com/office/drawing/2014/main" val="3796591160"/>
                    </a:ext>
                  </a:extLst>
                </a:gridCol>
                <a:gridCol w="890588">
                  <a:extLst>
                    <a:ext uri="{9D8B030D-6E8A-4147-A177-3AD203B41FA5}">
                      <a16:colId xmlns:a16="http://schemas.microsoft.com/office/drawing/2014/main" val="615296788"/>
                    </a:ext>
                  </a:extLst>
                </a:gridCol>
                <a:gridCol w="652462">
                  <a:extLst>
                    <a:ext uri="{9D8B030D-6E8A-4147-A177-3AD203B41FA5}">
                      <a16:colId xmlns:a16="http://schemas.microsoft.com/office/drawing/2014/main" val="3431563213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4348713"/>
                    </a:ext>
                  </a:extLst>
                </a:gridCol>
              </a:tblGrid>
              <a:tr h="250441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d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e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0(%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0(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 (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5761341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33008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2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7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8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6484543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J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94738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6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1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6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1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4916802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10538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8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0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7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70154919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55693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2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E+0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8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0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8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787096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12311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E+0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0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8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3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4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25014901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J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81854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6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9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5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038371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F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16562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9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7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1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0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4742210"/>
                  </a:ext>
                </a:extLst>
              </a:tr>
              <a:tr h="488999"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8152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5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1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8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2E+0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9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 hangingPunct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roid Sans Fallback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528414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77344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8</TotalTime>
  <Words>1619</Words>
  <Application>Microsoft Office PowerPoint</Application>
  <PresentationFormat>Widescreen</PresentationFormat>
  <Paragraphs>481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Arial</vt:lpstr>
      <vt:lpstr>Calibri</vt:lpstr>
      <vt:lpstr>Calibri Light</vt:lpstr>
      <vt:lpstr>Liberation Serif</vt:lpstr>
      <vt:lpstr>Palatino Linotype</vt:lpstr>
      <vt:lpstr>Times New Roman</vt:lpstr>
      <vt:lpstr>Office Theme</vt:lpstr>
      <vt:lpstr>Supplementary figures and tables </vt:lpstr>
      <vt:lpstr>PowerPoint Presentation</vt:lpstr>
      <vt:lpstr>Supplementary Figure S2.  Differential methylated profile between the wild oleaster (Delice) and cultivated Ayvalik within the 23 olive chromosomes.  Top figure : global hypomethylation with fruit maturity between July and November for Ayvalik fruits Bottom figure : global hypomethylation with fruit maturity between July and November for wild oleaster fruits AJF: Ayvalik July fruits; ANF: Ayvalik November fruit; DJF wild July fruits DNF wild November fruit</vt:lpstr>
      <vt:lpstr>PowerPoint Presentation</vt:lpstr>
      <vt:lpstr>PowerPoint Presentation</vt:lpstr>
      <vt:lpstr>Figure S5 Heatmap of leaves DNA methyltransferases differential genes expression (DGE) between July and November ( DGE data published in Turgay et all 2017)</vt:lpstr>
      <vt:lpstr>   Figure S6. Heatmap of fruit DNA methyltransferases differential genes expression between July and November ( DGE data published in Turgay et all 2017)   </vt:lpstr>
      <vt:lpstr>  Figure S7. Heatmap of fruits DNA demethylases differential genes expression between July and November  </vt:lpstr>
      <vt:lpstr>Table S1: Raw data statistic information </vt:lpstr>
      <vt:lpstr>Table S2: Statistics of clean data after QC and trimming  </vt:lpstr>
      <vt:lpstr>Table S3. Statistics of reads alignments 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</dc:title>
  <dc:creator>oussama badad</dc:creator>
  <cp:lastModifiedBy>oussama badad</cp:lastModifiedBy>
  <cp:revision>19</cp:revision>
  <dcterms:created xsi:type="dcterms:W3CDTF">2020-11-13T22:52:21Z</dcterms:created>
  <dcterms:modified xsi:type="dcterms:W3CDTF">2021-07-03T02:29:30Z</dcterms:modified>
</cp:coreProperties>
</file>